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904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06945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5336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7964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511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90623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69548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7591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57837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6401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87108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5874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47552-8A09-4D91-B472-1320FB9BB63A}" type="datetimeFigureOut">
              <a:rPr lang="en-CA" smtClean="0"/>
              <a:t>2016-04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6C0B0-3588-48F4-88CC-BE5BFE7CFBB4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04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0648" y="240013"/>
            <a:ext cx="261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 err="1" smtClean="0"/>
              <a:t>Sclerotium</a:t>
            </a:r>
            <a:r>
              <a:rPr lang="en-CA" sz="2400" dirty="0" smtClean="0"/>
              <a:t> erg0252</a:t>
            </a:r>
            <a:endParaRPr lang="en-CA" sz="2400" dirty="0"/>
          </a:p>
        </p:txBody>
      </p:sp>
      <p:sp>
        <p:nvSpPr>
          <p:cNvPr id="3" name="TextBox 2"/>
          <p:cNvSpPr txBox="1"/>
          <p:nvPr/>
        </p:nvSpPr>
        <p:spPr>
          <a:xfrm>
            <a:off x="476460" y="100295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i="1" dirty="0" smtClean="0"/>
              <a:t>cpn60</a:t>
            </a:r>
            <a:endParaRPr lang="en-CA" i="1" dirty="0"/>
          </a:p>
        </p:txBody>
      </p:sp>
      <p:sp>
        <p:nvSpPr>
          <p:cNvPr id="4" name="TextBox 3"/>
          <p:cNvSpPr txBox="1"/>
          <p:nvPr/>
        </p:nvSpPr>
        <p:spPr>
          <a:xfrm>
            <a:off x="476460" y="5436096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ITS</a:t>
            </a:r>
            <a:endParaRPr lang="en-CA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074" y="1187624"/>
            <a:ext cx="4788743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532" y="5220072"/>
            <a:ext cx="4081983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93236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1331640"/>
            <a:ext cx="4218843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60648" y="240013"/>
            <a:ext cx="261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 err="1" smtClean="0"/>
              <a:t>Sclerotium</a:t>
            </a:r>
            <a:r>
              <a:rPr lang="en-CA" sz="2400" dirty="0" smtClean="0"/>
              <a:t> erg0253</a:t>
            </a:r>
            <a:endParaRPr lang="en-CA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476460" y="100295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i="1" dirty="0" smtClean="0"/>
              <a:t>cpn60</a:t>
            </a:r>
            <a:endParaRPr lang="en-CA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76460" y="5436096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ITS</a:t>
            </a:r>
            <a:endParaRPr lang="en-CA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6553" y="4954010"/>
            <a:ext cx="3781930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600768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0648" y="240013"/>
            <a:ext cx="261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 err="1" smtClean="0"/>
              <a:t>Sclerotium</a:t>
            </a:r>
            <a:r>
              <a:rPr lang="en-CA" sz="2400" dirty="0" smtClean="0"/>
              <a:t> erg0254</a:t>
            </a:r>
            <a:endParaRPr lang="en-CA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476460" y="100295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i="1" dirty="0" smtClean="0"/>
              <a:t>cpn60</a:t>
            </a:r>
            <a:endParaRPr lang="en-CA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76460" y="5436096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ITS</a:t>
            </a:r>
            <a:endParaRPr lang="en-CA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1375771"/>
            <a:ext cx="4393115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5688" y="5220072"/>
            <a:ext cx="4433752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53497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0648" y="240013"/>
            <a:ext cx="261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 err="1" smtClean="0"/>
              <a:t>Sclerotium</a:t>
            </a:r>
            <a:r>
              <a:rPr lang="en-CA" sz="2400" dirty="0" smtClean="0"/>
              <a:t> erg0256</a:t>
            </a:r>
            <a:endParaRPr lang="en-CA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476460" y="100295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i="1" dirty="0" smtClean="0"/>
              <a:t>cpn60</a:t>
            </a:r>
            <a:endParaRPr lang="en-CA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76460" y="5436096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ITS</a:t>
            </a:r>
            <a:endParaRPr lang="en-CA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8344" y="1547664"/>
            <a:ext cx="3770162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2274" y="5147664"/>
            <a:ext cx="3926232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53688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0648" y="240013"/>
            <a:ext cx="261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 err="1" smtClean="0"/>
              <a:t>Sclerotium</a:t>
            </a:r>
            <a:r>
              <a:rPr lang="en-CA" sz="2400" dirty="0" smtClean="0"/>
              <a:t> erg0258</a:t>
            </a:r>
            <a:endParaRPr lang="en-CA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476460" y="100295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i="1" dirty="0" smtClean="0"/>
              <a:t>cpn60</a:t>
            </a:r>
            <a:endParaRPr lang="en-CA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76460" y="5436096"/>
            <a:ext cx="45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ITS</a:t>
            </a:r>
            <a:endParaRPr lang="en-CA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1541" y="1462088"/>
            <a:ext cx="3908729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6532" y="5292080"/>
            <a:ext cx="4081983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11485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20</Words>
  <Application>Microsoft Office PowerPoint</Application>
  <PresentationFormat>On-screen Show (4:3)</PresentationFormat>
  <Paragraphs>1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 Dumonceaux</dc:creator>
  <cp:lastModifiedBy>Tim Dumonceaux</cp:lastModifiedBy>
  <cp:revision>9</cp:revision>
  <dcterms:created xsi:type="dcterms:W3CDTF">2016-04-29T16:28:59Z</dcterms:created>
  <dcterms:modified xsi:type="dcterms:W3CDTF">2016-04-29T18:09:48Z</dcterms:modified>
</cp:coreProperties>
</file>